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D8969E-1B7C-40D3-9684-B5526DCA54A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7AC3D5-FCAB-40D2-8B02-2BC4E3F5F5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0CDFB4-66EE-4C20-B5AB-0B5D3FD0686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1081E7-31E0-434B-AF83-D89709E21A1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EA1C83-A3CF-4D7C-BD0E-1F2D3E3C9F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507A4E-2030-4319-AA68-D4A0734D44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6D6357-CCC1-4351-956B-F81437B180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333818-EF62-4774-A517-7905DE6E53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928A9B-52E2-4805-B98D-A5281A4A51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F9C7EA-7846-46C0-9E2A-7BF4955778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821164-29AD-4311-A2EE-349B72A4A1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2C698D-03DF-4F78-88E9-A17EA92C22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3EBF52-F289-4A45-9096-613A6B0FFFF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-2880" y="5024520"/>
            <a:ext cx="45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-2880" y="344520"/>
            <a:ext cx="45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474840" y="4881600"/>
            <a:ext cx="5837040" cy="325260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4752720" y="7962840"/>
            <a:ext cx="12643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Arial"/>
              </a:rPr>
              <a:t>RCC4-VH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Arial"/>
              </a:rPr>
              <a:t>untransfect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911320" y="7956720"/>
            <a:ext cx="153540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Arial"/>
              </a:rPr>
              <a:t>RCC4-VHL transfected with negative contr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220760" y="7977240"/>
            <a:ext cx="153504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Arial"/>
              </a:rPr>
              <a:t>RCC4-VHL transfected with miR-210 antagomi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912240" y="77547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618840" y="7182000"/>
            <a:ext cx="59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x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-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633240" y="6640560"/>
            <a:ext cx="59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x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-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94640" y="6093000"/>
            <a:ext cx="71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.5x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-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622080" y="5567400"/>
            <a:ext cx="59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x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-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82040" y="5033880"/>
            <a:ext cx="71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.5x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-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rot="16200000">
            <a:off x="-1168920" y="6402960"/>
            <a:ext cx="30178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SCU1/2 Mean Normalised Express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" descr=""/>
          <p:cNvPicPr/>
          <p:nvPr/>
        </p:nvPicPr>
        <p:blipFill>
          <a:blip r:embed="rId2"/>
          <a:stretch/>
        </p:blipFill>
        <p:spPr>
          <a:xfrm>
            <a:off x="436680" y="992160"/>
            <a:ext cx="5837040" cy="3252960"/>
          </a:xfrm>
          <a:prstGeom prst="rect">
            <a:avLst/>
          </a:prstGeom>
          <a:ln w="0">
            <a:noFill/>
          </a:ln>
        </p:spPr>
      </p:pic>
      <p:sp>
        <p:nvSpPr>
          <p:cNvPr id="55" name=""/>
          <p:cNvSpPr/>
          <p:nvPr/>
        </p:nvSpPr>
        <p:spPr>
          <a:xfrm>
            <a:off x="1201680" y="4033800"/>
            <a:ext cx="15350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Arial"/>
              </a:rPr>
              <a:t>RCC4+VHL transfected with miR-210 mimi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917800" y="4033800"/>
            <a:ext cx="15350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Arial"/>
              </a:rPr>
              <a:t>RCC4+VHL transfected with negative contr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719240" y="4044960"/>
            <a:ext cx="12643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Arial"/>
              </a:rPr>
              <a:t>RCC4+VH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Arial"/>
              </a:rPr>
              <a:t>untransfect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877320" y="3825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612720" y="3097080"/>
            <a:ext cx="59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x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-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612720" y="2470320"/>
            <a:ext cx="59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x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-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609480" y="1795320"/>
            <a:ext cx="59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x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-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610920" y="1130400"/>
            <a:ext cx="59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x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-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rot="16200000">
            <a:off x="-1165680" y="2054880"/>
            <a:ext cx="30178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SCU1/2 Mean Normalised Express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25T02:25:58Z</dcterms:created>
  <dc:creator>CNEAL01</dc:creator>
  <dc:description/>
  <dc:language>en-US</dc:language>
  <cp:lastModifiedBy>CNEAL01</cp:lastModifiedBy>
  <dcterms:modified xsi:type="dcterms:W3CDTF">2010-07-16T06:35:04Z</dcterms:modified>
  <cp:revision>10</cp:revision>
  <dc:subject/>
  <dc:title>Slide 1</dc:title>
</cp:coreProperties>
</file>